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2239625" cy="864076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7972" y="1414125"/>
            <a:ext cx="10403681" cy="3008266"/>
          </a:xfrm>
        </p:spPr>
        <p:txBody>
          <a:bodyPr anchor="b"/>
          <a:lstStyle>
            <a:lvl1pPr algn="ctr">
              <a:defRPr sz="7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9953" y="4538401"/>
            <a:ext cx="9179719" cy="2086184"/>
          </a:xfrm>
        </p:spPr>
        <p:txBody>
          <a:bodyPr/>
          <a:lstStyle>
            <a:lvl1pPr marL="0" indent="0" algn="ctr">
              <a:buNone/>
              <a:defRPr sz="3024"/>
            </a:lvl1pPr>
            <a:lvl2pPr marL="576072" indent="0" algn="ctr">
              <a:buNone/>
              <a:defRPr sz="2520"/>
            </a:lvl2pPr>
            <a:lvl3pPr marL="1152144" indent="0" algn="ctr">
              <a:buNone/>
              <a:defRPr sz="2268"/>
            </a:lvl3pPr>
            <a:lvl4pPr marL="1728216" indent="0" algn="ctr">
              <a:buNone/>
              <a:defRPr sz="2016"/>
            </a:lvl4pPr>
            <a:lvl5pPr marL="2304288" indent="0" algn="ctr">
              <a:buNone/>
              <a:defRPr sz="2016"/>
            </a:lvl5pPr>
            <a:lvl6pPr marL="2880360" indent="0" algn="ctr">
              <a:buNone/>
              <a:defRPr sz="2016"/>
            </a:lvl6pPr>
            <a:lvl7pPr marL="3456432" indent="0" algn="ctr">
              <a:buNone/>
              <a:defRPr sz="2016"/>
            </a:lvl7pPr>
            <a:lvl8pPr marL="4032504" indent="0" algn="ctr">
              <a:buNone/>
              <a:defRPr sz="2016"/>
            </a:lvl8pPr>
            <a:lvl9pPr marL="4608576" indent="0" algn="ctr">
              <a:buNone/>
              <a:defRPr sz="201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820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1871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58982" y="460041"/>
            <a:ext cx="2639169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1475" y="460041"/>
            <a:ext cx="7764512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0154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8015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100" y="2154193"/>
            <a:ext cx="10556677" cy="3594317"/>
          </a:xfrm>
        </p:spPr>
        <p:txBody>
          <a:bodyPr anchor="b"/>
          <a:lstStyle>
            <a:lvl1pPr>
              <a:defRPr sz="7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100" y="5782513"/>
            <a:ext cx="10556677" cy="1890166"/>
          </a:xfrm>
        </p:spPr>
        <p:txBody>
          <a:bodyPr/>
          <a:lstStyle>
            <a:lvl1pPr marL="0" indent="0">
              <a:buNone/>
              <a:defRPr sz="3024">
                <a:solidFill>
                  <a:schemeClr val="tx1"/>
                </a:solidFill>
              </a:defRPr>
            </a:lvl1pPr>
            <a:lvl2pPr marL="576072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472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1474" y="2300203"/>
            <a:ext cx="5201841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6310" y="2300203"/>
            <a:ext cx="5201841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0834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460043"/>
            <a:ext cx="10556677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070" y="2118188"/>
            <a:ext cx="5177934" cy="1038091"/>
          </a:xfrm>
        </p:spPr>
        <p:txBody>
          <a:bodyPr anchor="b"/>
          <a:lstStyle>
            <a:lvl1pPr marL="0" indent="0">
              <a:buNone/>
              <a:defRPr sz="3024" b="1"/>
            </a:lvl1pPr>
            <a:lvl2pPr marL="576072" indent="0">
              <a:buNone/>
              <a:defRPr sz="2520" b="1"/>
            </a:lvl2pPr>
            <a:lvl3pPr marL="1152144" indent="0">
              <a:buNone/>
              <a:defRPr sz="2268" b="1"/>
            </a:lvl3pPr>
            <a:lvl4pPr marL="1728216" indent="0">
              <a:buNone/>
              <a:defRPr sz="2016" b="1"/>
            </a:lvl4pPr>
            <a:lvl5pPr marL="2304288" indent="0">
              <a:buNone/>
              <a:defRPr sz="2016" b="1"/>
            </a:lvl5pPr>
            <a:lvl6pPr marL="2880360" indent="0">
              <a:buNone/>
              <a:defRPr sz="2016" b="1"/>
            </a:lvl6pPr>
            <a:lvl7pPr marL="3456432" indent="0">
              <a:buNone/>
              <a:defRPr sz="2016" b="1"/>
            </a:lvl7pPr>
            <a:lvl8pPr marL="4032504" indent="0">
              <a:buNone/>
              <a:defRPr sz="2016" b="1"/>
            </a:lvl8pPr>
            <a:lvl9pPr marL="4608576" indent="0">
              <a:buNone/>
              <a:defRPr sz="201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070" y="3156278"/>
            <a:ext cx="5177934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6311" y="2118188"/>
            <a:ext cx="5203435" cy="1038091"/>
          </a:xfrm>
        </p:spPr>
        <p:txBody>
          <a:bodyPr anchor="b"/>
          <a:lstStyle>
            <a:lvl1pPr marL="0" indent="0">
              <a:buNone/>
              <a:defRPr sz="3024" b="1"/>
            </a:lvl1pPr>
            <a:lvl2pPr marL="576072" indent="0">
              <a:buNone/>
              <a:defRPr sz="2520" b="1"/>
            </a:lvl2pPr>
            <a:lvl3pPr marL="1152144" indent="0">
              <a:buNone/>
              <a:defRPr sz="2268" b="1"/>
            </a:lvl3pPr>
            <a:lvl4pPr marL="1728216" indent="0">
              <a:buNone/>
              <a:defRPr sz="2016" b="1"/>
            </a:lvl4pPr>
            <a:lvl5pPr marL="2304288" indent="0">
              <a:buNone/>
              <a:defRPr sz="2016" b="1"/>
            </a:lvl5pPr>
            <a:lvl6pPr marL="2880360" indent="0">
              <a:buNone/>
              <a:defRPr sz="2016" b="1"/>
            </a:lvl6pPr>
            <a:lvl7pPr marL="3456432" indent="0">
              <a:buNone/>
              <a:defRPr sz="2016" b="1"/>
            </a:lvl7pPr>
            <a:lvl8pPr marL="4032504" indent="0">
              <a:buNone/>
              <a:defRPr sz="2016" b="1"/>
            </a:lvl8pPr>
            <a:lvl9pPr marL="4608576" indent="0">
              <a:buNone/>
              <a:defRPr sz="201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6311" y="3156278"/>
            <a:ext cx="5203435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6982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809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2049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576051"/>
            <a:ext cx="3947598" cy="2016178"/>
          </a:xfrm>
        </p:spPr>
        <p:txBody>
          <a:bodyPr anchor="b"/>
          <a:lstStyle>
            <a:lvl1pPr>
              <a:defRPr sz="403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3435" y="1244112"/>
            <a:ext cx="6196310" cy="6140542"/>
          </a:xfrm>
        </p:spPr>
        <p:txBody>
          <a:bodyPr/>
          <a:lstStyle>
            <a:lvl1pPr>
              <a:defRPr sz="4032"/>
            </a:lvl1pPr>
            <a:lvl2pPr>
              <a:defRPr sz="3528"/>
            </a:lvl2pPr>
            <a:lvl3pPr>
              <a:defRPr sz="3024"/>
            </a:lvl3pPr>
            <a:lvl4pPr>
              <a:defRPr sz="2520"/>
            </a:lvl4pPr>
            <a:lvl5pPr>
              <a:defRPr sz="2520"/>
            </a:lvl5pPr>
            <a:lvl6pPr>
              <a:defRPr sz="2520"/>
            </a:lvl6pPr>
            <a:lvl7pPr>
              <a:defRPr sz="2520"/>
            </a:lvl7pPr>
            <a:lvl8pPr>
              <a:defRPr sz="2520"/>
            </a:lvl8pPr>
            <a:lvl9pPr>
              <a:defRPr sz="25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8" y="2592229"/>
            <a:ext cx="3947598" cy="4802425"/>
          </a:xfrm>
        </p:spPr>
        <p:txBody>
          <a:bodyPr/>
          <a:lstStyle>
            <a:lvl1pPr marL="0" indent="0">
              <a:buNone/>
              <a:defRPr sz="2016"/>
            </a:lvl1pPr>
            <a:lvl2pPr marL="576072" indent="0">
              <a:buNone/>
              <a:defRPr sz="1764"/>
            </a:lvl2pPr>
            <a:lvl3pPr marL="1152144" indent="0">
              <a:buNone/>
              <a:defRPr sz="1512"/>
            </a:lvl3pPr>
            <a:lvl4pPr marL="1728216" indent="0">
              <a:buNone/>
              <a:defRPr sz="1260"/>
            </a:lvl4pPr>
            <a:lvl5pPr marL="2304288" indent="0">
              <a:buNone/>
              <a:defRPr sz="1260"/>
            </a:lvl5pPr>
            <a:lvl6pPr marL="2880360" indent="0">
              <a:buNone/>
              <a:defRPr sz="1260"/>
            </a:lvl6pPr>
            <a:lvl7pPr marL="3456432" indent="0">
              <a:buNone/>
              <a:defRPr sz="1260"/>
            </a:lvl7pPr>
            <a:lvl8pPr marL="4032504" indent="0">
              <a:buNone/>
              <a:defRPr sz="1260"/>
            </a:lvl8pPr>
            <a:lvl9pPr marL="4608576" indent="0">
              <a:buNone/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846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576051"/>
            <a:ext cx="3947598" cy="2016178"/>
          </a:xfrm>
        </p:spPr>
        <p:txBody>
          <a:bodyPr anchor="b"/>
          <a:lstStyle>
            <a:lvl1pPr>
              <a:defRPr sz="403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3435" y="1244112"/>
            <a:ext cx="6196310" cy="6140542"/>
          </a:xfrm>
        </p:spPr>
        <p:txBody>
          <a:bodyPr anchor="t"/>
          <a:lstStyle>
            <a:lvl1pPr marL="0" indent="0">
              <a:buNone/>
              <a:defRPr sz="4032"/>
            </a:lvl1pPr>
            <a:lvl2pPr marL="576072" indent="0">
              <a:buNone/>
              <a:defRPr sz="3528"/>
            </a:lvl2pPr>
            <a:lvl3pPr marL="1152144" indent="0">
              <a:buNone/>
              <a:defRPr sz="3024"/>
            </a:lvl3pPr>
            <a:lvl4pPr marL="1728216" indent="0">
              <a:buNone/>
              <a:defRPr sz="2520"/>
            </a:lvl4pPr>
            <a:lvl5pPr marL="2304288" indent="0">
              <a:buNone/>
              <a:defRPr sz="2520"/>
            </a:lvl5pPr>
            <a:lvl6pPr marL="2880360" indent="0">
              <a:buNone/>
              <a:defRPr sz="2520"/>
            </a:lvl6pPr>
            <a:lvl7pPr marL="3456432" indent="0">
              <a:buNone/>
              <a:defRPr sz="2520"/>
            </a:lvl7pPr>
            <a:lvl8pPr marL="4032504" indent="0">
              <a:buNone/>
              <a:defRPr sz="2520"/>
            </a:lvl8pPr>
            <a:lvl9pPr marL="4608576" indent="0">
              <a:buNone/>
              <a:defRPr sz="25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8" y="2592229"/>
            <a:ext cx="3947598" cy="4802425"/>
          </a:xfrm>
        </p:spPr>
        <p:txBody>
          <a:bodyPr/>
          <a:lstStyle>
            <a:lvl1pPr marL="0" indent="0">
              <a:buNone/>
              <a:defRPr sz="2016"/>
            </a:lvl1pPr>
            <a:lvl2pPr marL="576072" indent="0">
              <a:buNone/>
              <a:defRPr sz="1764"/>
            </a:lvl2pPr>
            <a:lvl3pPr marL="1152144" indent="0">
              <a:buNone/>
              <a:defRPr sz="1512"/>
            </a:lvl3pPr>
            <a:lvl4pPr marL="1728216" indent="0">
              <a:buNone/>
              <a:defRPr sz="1260"/>
            </a:lvl4pPr>
            <a:lvl5pPr marL="2304288" indent="0">
              <a:buNone/>
              <a:defRPr sz="1260"/>
            </a:lvl5pPr>
            <a:lvl6pPr marL="2880360" indent="0">
              <a:buNone/>
              <a:defRPr sz="1260"/>
            </a:lvl6pPr>
            <a:lvl7pPr marL="3456432" indent="0">
              <a:buNone/>
              <a:defRPr sz="1260"/>
            </a:lvl7pPr>
            <a:lvl8pPr marL="4032504" indent="0">
              <a:buNone/>
              <a:defRPr sz="1260"/>
            </a:lvl8pPr>
            <a:lvl9pPr marL="4608576" indent="0">
              <a:buNone/>
              <a:defRPr sz="126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7904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1474" y="460043"/>
            <a:ext cx="10556677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1474" y="2300203"/>
            <a:ext cx="10556677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1474" y="8008709"/>
            <a:ext cx="2753916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35056-9BF9-41F2-A7E3-4A4206E0E02E}" type="datetimeFigureOut">
              <a:rPr lang="en-GB" smtClean="0"/>
              <a:t>12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4376" y="8008709"/>
            <a:ext cx="4130873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44235" y="8008709"/>
            <a:ext cx="2753916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1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A9DA8-FB58-4EB2-8BA8-EC7D5AFFDE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0800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152144" rtl="0" eaLnBrk="1" latinLnBrk="0" hangingPunct="1">
        <a:lnSpc>
          <a:spcPct val="90000"/>
        </a:lnSpc>
        <a:spcBef>
          <a:spcPct val="0"/>
        </a:spcBef>
        <a:buNone/>
        <a:defRPr sz="55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8036" indent="-288036" algn="l" defTabSz="1152144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3528" kern="1200">
          <a:solidFill>
            <a:schemeClr val="tx1"/>
          </a:solidFill>
          <a:latin typeface="+mn-lt"/>
          <a:ea typeface="+mn-ea"/>
          <a:cs typeface="+mn-cs"/>
        </a:defRPr>
      </a:lvl1pPr>
      <a:lvl2pPr marL="864108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26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A37D886-C92A-4BFE-ABC4-33A3E7AB0FB4}"/>
              </a:ext>
            </a:extLst>
          </p:cNvPr>
          <p:cNvSpPr/>
          <p:nvPr/>
        </p:nvSpPr>
        <p:spPr>
          <a:xfrm>
            <a:off x="992822" y="688386"/>
            <a:ext cx="10558780" cy="77559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 20         *        40         *        60         *        80         *       100         *       120         *       1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ATATGAAAAAGTAAAA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GAAACCTATCA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AAA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AAAGA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GTTG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CAAGGAAGGAAG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C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GAA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141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----------------------------------------------------------------------------------------------------------------------------------------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 :   12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-----------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GAAACCTATCA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AAA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AAAGA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GTTG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CAAGGAAGGAAG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C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TG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GAA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131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160         *       180         *       200         *       220         *       240         *       260         *       280         *       300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G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A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T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G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A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287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GC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GGT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GTGGGAG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GA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CC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 :  15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G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AACAAAA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T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G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A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275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320         *       340         *       360         *       380         *       400         *       420         *       4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TTCAT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T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437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GG---C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--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G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-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AGCCGA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GG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 :  291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T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424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460         *       480         *       500         *       520         *       540         *       560         *       580         *       600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T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TTATAT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G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TTGAGATATACGCACAC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CTAAGGAT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TCAA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TATAGTACCG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586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G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G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GAGC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TTGAGATATACGCACAC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CTAAGGAT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TCAA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TATAGTACCG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436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T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TTATAT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G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TTGAGATATACGCACAC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CTAAGGAT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TCAAC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TATAGTACCG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57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620         *       640         *       660         *       680         *       700         *       720         *       7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AGTGACAACCTAGCACATGCTTGATTAT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TCCTATTG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AATATTCATTC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AATGAAATGAAGGCGAGAAATAATACCTTGCATTGGCAGAAGAAATTA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736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AGTGACAACCTAGCACATGCTTGATTAT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TCCTATTG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AATATTCATTC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AATGAAATGAAGGCGAGAAATAATACCTTGCATTGGCAGAAGAAATTA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586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TCAGTGACAACCTAGCACATGCTTGATTAT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TCCTATTG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G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AATATTCATTC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TAATGAAATGAAGGCGAGAAATAATACCTTGCATTGGCAGAAGAAATTA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72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760         *       780         *       800         *       820         *       840         *       860         *       880         *       900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TTTTGTTATCTTTTGTATGTCTTTTTA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AGTTTATTT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TTCTGTTAGAG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T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GGTGATTGTCTTTAACCTAACCCGCA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ATGCATAA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884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TTTTGTTATCTTTTGTATGTCTTTTTA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AGTTTATTT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TTCTGTTAGAG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T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GGTGATTGTCTTTAACCTAACCCGCA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ATGCATAA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73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TTTTGTTATCTTTTGTATGTCTTTTTA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AGTTTATTT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TTCTGTTAGAG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T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GGTGATTGTCTTTAACCTAACCCGCAA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ATGCATAA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872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 920         *       940         *       960         *       980         *      1000         *      1020         *      10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AGCCGTT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GATTGGTTG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ACA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TGTAC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G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AGCGTGTGTTTTTCT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TGCATGTTTGCTA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A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03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AGCCGTT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GATTGGTTG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AC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TGTACA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G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AGCGTGTGTTTTTCT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TGCATGTTTGCTA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A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 882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AGCCGTTT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AGATTGGTTG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ACA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CATGTACA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CA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GGG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GAGCGTGTGTTTTTCTC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ATGCATGTTTGCTA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GA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021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1060         *      1080         *      1100         *      1120         *      1140         *      1160         *      1180         *      1200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TTTAT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TC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------------------------------------------------------------------------------------------------------ : 1058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TTTAT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TC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CCGTTCTTAAATATTTGTCCTTTTAGAGATTTCAAATGGACTACCACATACCGGATGTATATAGACATATTTTAGAGTGTAGATTCACTTATTTTGCTCCGTATGTAGTCACTTGTTGAAAT : 1032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TTTAT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TC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------------------------------------------------------------------------------------------------------ : 1046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1220         *      1240         *      1260         *      1280         *      1300         *      1320         *      13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------------------------------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AA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CCCTAACAA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TTTACAAAAGAGTTGGT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GGTTAAG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A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ACT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TTGATTG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16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CTCTAGAAAAATAAATATTTAAGAACGAAGGGAGTAC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AAG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CCCTAACA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TTTACAAAAGAGTTGG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GGTTAAG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A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ACT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TTGATTG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182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------------------------------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AA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CCCTAACAA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TTTACAAAAGAGTTGGT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C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GGTTAAG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AA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ACT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TTGCTTGATTG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154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1360         *      1380         *      1400         *      1420         *      1440         *      1460         *      1480         *      1500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GT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CCTGTTC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GAA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ATGGGCC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CTTAGCTGGC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GAGGCCTTCAAA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CCACCTCGTCGCAGCC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300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G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CCTGTTCAA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GAAT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ATGGGCCG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CTTAGCTGGC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-------------------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GAGGCCTTCAAA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CCACCTCGTCGCAGCCG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301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G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TCCTGTTCAA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TTTGAAT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AATGGGCC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GCTTAGCTGGC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TGGTGTTA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AG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GAGGCCTTCAAAT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CCCACCTCGTCGCAGCCG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GA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304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                        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*      1520         *      1540         *      1560         *      1580         *      1600         *      1620         *      1640         *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CATTCCACCCGCACCTGCGCTTCCCAAACCTCCCCTCTCCCCCAG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CCAC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AGC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GGTCTCGTCCTCCTCCACCGCTTCCACTCGCCGTCTTCGC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450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CATTCCACCCGCACCTGCGCTTCCCAAACCTCCCCTCTCCCCCAGC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CCACT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AGCA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GGTCTCGTCCTCCTCCACCGCTTCCACTCGCCGTCTTCGCT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450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CATTCCACCCGCACCTGCGCTTCCCAAACCTCCCCTCTCCCCCAG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CCCACT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----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GCAGCA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T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CAGGTCTCGTCCTCCTCCACCGCTTCCACTCGCCGTCTTCGCT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450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1660         *      1680         *      1700          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A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GCTC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CC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CGCAGGC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GCGGGA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50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B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GCT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CCTT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CGCAGG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GCGGGA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50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800" b="1" i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aDmc1-D1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CA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CTCGCT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CACCT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CCT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TGACGCAGGCG</a:t>
            </a:r>
            <a:r>
              <a:rPr lang="en-GB" sz="800" b="1" dirty="0">
                <a:solidFill>
                  <a:srgbClr val="FFFFFF"/>
                </a:solidFill>
                <a:highlight>
                  <a:srgbClr val="80808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800" b="1" dirty="0">
                <a:solidFill>
                  <a:srgbClr val="FFFFFF"/>
                </a:solidFill>
                <a:highlight>
                  <a:srgbClr val="000000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CACGCGGGATG</a:t>
            </a:r>
            <a: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  <a:t> : 1503</a:t>
            </a:r>
            <a:br>
              <a:rPr lang="en-GB" sz="800" b="1" dirty="0">
                <a:solidFill>
                  <a:srgbClr val="000000"/>
                </a:solidFill>
                <a:highlight>
                  <a:srgbClr val="FFFFFF"/>
                </a:highlight>
                <a:latin typeface="Courier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531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ul Kader Alabdullah (JIC)</dc:creator>
  <cp:lastModifiedBy>Tracie Draeger (JIC)</cp:lastModifiedBy>
  <cp:revision>3</cp:revision>
  <dcterms:created xsi:type="dcterms:W3CDTF">2019-08-28T11:00:37Z</dcterms:created>
  <dcterms:modified xsi:type="dcterms:W3CDTF">2019-09-12T10:57:34Z</dcterms:modified>
</cp:coreProperties>
</file>